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100" d="100"/>
          <a:sy n="100" d="100"/>
        </p:scale>
        <p:origin x="117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 smtClean="0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C57C-745E-46EF-A4D2-D23E19C8D729}" type="datetimeFigureOut">
              <a:rPr lang="es-ES" smtClean="0"/>
              <a:t>08/01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2C13B-99D1-4E17-A1AB-90C6718C3B9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581195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C57C-745E-46EF-A4D2-D23E19C8D729}" type="datetimeFigureOut">
              <a:rPr lang="es-ES" smtClean="0"/>
              <a:t>08/01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2C13B-99D1-4E17-A1AB-90C6718C3B9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559284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C57C-745E-46EF-A4D2-D23E19C8D729}" type="datetimeFigureOut">
              <a:rPr lang="es-ES" smtClean="0"/>
              <a:t>08/01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2C13B-99D1-4E17-A1AB-90C6718C3B9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422549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C57C-745E-46EF-A4D2-D23E19C8D729}" type="datetimeFigureOut">
              <a:rPr lang="es-ES" smtClean="0"/>
              <a:t>08/01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2C13B-99D1-4E17-A1AB-90C6718C3B9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425993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C57C-745E-46EF-A4D2-D23E19C8D729}" type="datetimeFigureOut">
              <a:rPr lang="es-ES" smtClean="0"/>
              <a:t>08/01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2C13B-99D1-4E17-A1AB-90C6718C3B9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84133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C57C-745E-46EF-A4D2-D23E19C8D729}" type="datetimeFigureOut">
              <a:rPr lang="es-ES" smtClean="0"/>
              <a:t>08/01/201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2C13B-99D1-4E17-A1AB-90C6718C3B9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569593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C57C-745E-46EF-A4D2-D23E19C8D729}" type="datetimeFigureOut">
              <a:rPr lang="es-ES" smtClean="0"/>
              <a:t>08/01/2016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2C13B-99D1-4E17-A1AB-90C6718C3B9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486252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C57C-745E-46EF-A4D2-D23E19C8D729}" type="datetimeFigureOut">
              <a:rPr lang="es-ES" smtClean="0"/>
              <a:t>08/01/2016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2C13B-99D1-4E17-A1AB-90C6718C3B9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951280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C57C-745E-46EF-A4D2-D23E19C8D729}" type="datetimeFigureOut">
              <a:rPr lang="es-ES" smtClean="0"/>
              <a:t>08/01/2016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2C13B-99D1-4E17-A1AB-90C6718C3B9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702247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C57C-745E-46EF-A4D2-D23E19C8D729}" type="datetimeFigureOut">
              <a:rPr lang="es-ES" smtClean="0"/>
              <a:t>08/01/201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2C13B-99D1-4E17-A1AB-90C6718C3B9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700739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C57C-745E-46EF-A4D2-D23E19C8D729}" type="datetimeFigureOut">
              <a:rPr lang="es-ES" smtClean="0"/>
              <a:t>08/01/201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2C13B-99D1-4E17-A1AB-90C6718C3B9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203233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94C57C-745E-46EF-A4D2-D23E19C8D729}" type="datetimeFigureOut">
              <a:rPr lang="es-ES" smtClean="0"/>
              <a:t>08/01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D2C13B-99D1-4E17-A1AB-90C6718C3B9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830579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a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8914161"/>
              </p:ext>
            </p:extLst>
          </p:nvPr>
        </p:nvGraphicFramePr>
        <p:xfrm>
          <a:off x="419675" y="3043706"/>
          <a:ext cx="5746303" cy="5802300"/>
        </p:xfrm>
        <a:graphic>
          <a:graphicData uri="http://schemas.openxmlformats.org/drawingml/2006/table">
            <a:tbl>
              <a:tblPr/>
              <a:tblGrid>
                <a:gridCol w="2260841"/>
                <a:gridCol w="1186941"/>
                <a:gridCol w="2298521"/>
              </a:tblGrid>
              <a:tr h="116046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Sulfur compound metabolic process (2)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Carbohydrate derivative metabolic process (3)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-phosphogluconate dehydrogen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nol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droxyacylglutathione hydrol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-phosphogluconate dehydrogen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Small molecule metabolic process (5)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xokin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tinal dehydrogenase 1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Carbohydrate  metabolic process (3)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nol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nol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-phosphogluconate dehydrogen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-phosphogluconate dehydrogen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xokin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xokin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ate dehydrogen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Cellular aldehyde metabolic process (2)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Single-organism catabolic process (2)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tinal dehydrogenase 1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nol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-phosphogluconate dehydrogen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xokin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Cellular aromatic compound metabolic process (4)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Single-organism biosynthetic process (2)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nol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-phosphogluconate dehydrogen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-phosphogluconate dehydrogen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ate dehydrogen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xokin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Regulation of metabolic process (3)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ate dehydrogen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nol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Cellular biosynthetic process (4)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-phosphogluconate dehydrogen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nol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ate dehydrogen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-phosphogluconate dehydrogen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Regulation of cellular process (2)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droxyacylglutathione hydrol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nol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ate dehydrogen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ate dehydrogen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Cellular nitrogen compound metabolic process (5)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Phosphorus metabolic process (4)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nol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nol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-phosphogluconate dehydrogen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-phosphogluconate dehydrogen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droxyacylglutathione hydrol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xokin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xokin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ate dehydrogen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ate dehydrogen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Oxidation-reduction process (2)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Cofactor metabolic process (4)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-phosphogluconate dehydrogen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nol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ate dehydrogen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-phosphogluconate dehydrogen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Organonitrogen compound metabolic process (5)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xokin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nolase</a:t>
                      </a:r>
                    </a:p>
                  </a:txBody>
                  <a:tcPr marL="5802" marR="5802" marT="58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ate dehydrogen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-phosphogluconate dehydrogenase</a:t>
                      </a:r>
                    </a:p>
                  </a:txBody>
                  <a:tcPr marL="5802" marR="5802" marT="58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Generation of precursor metabolites and energy (2)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ydroxyacylglutathione hydrolase</a:t>
                      </a:r>
                    </a:p>
                  </a:txBody>
                  <a:tcPr marL="5802" marR="5802" marT="58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nol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xokinase</a:t>
                      </a:r>
                    </a:p>
                  </a:txBody>
                  <a:tcPr marL="5802" marR="5802" marT="58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xokin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ate dehydrogenase</a:t>
                      </a:r>
                    </a:p>
                  </a:txBody>
                  <a:tcPr marL="5802" marR="5802" marT="58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Heterocycle metabolic process (4)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Organic substance catabolic process (4)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nol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nol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-phosphogluconate dehydrogen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xokin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xokin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Organic substance biosynthetic process (4)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ate dehydrogen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nol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Lipid metabolic process (2)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-phosphogluconate dehydrogen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tinal dehydrogenase 1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xokin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ate dehydrogen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ate dehydrogen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Macromolecule metabolic process (3)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Organic compound metabolic process (4)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nol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nol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-phosphogluconate dehydrogen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-phosphogluconate dehydrogen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eucine aminopeptid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xokin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Multicellular organismal development (2)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late dehydrogenase</a:t>
                      </a:r>
                    </a:p>
                  </a:txBody>
                  <a:tcPr marL="5802" marR="5802" marT="580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tinal dehydrogenase 1</a:t>
                      </a:r>
                    </a:p>
                  </a:txBody>
                  <a:tcPr marL="5802" marR="5802" marT="58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6046">
                <a:tc>
                  <a:txBody>
                    <a:bodyPr/>
                    <a:lstStyle/>
                    <a:p>
                      <a:pPr algn="l" fontAlgn="b"/>
                      <a:endParaRPr lang="es-E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-phosphogluconate </a:t>
                      </a:r>
                      <a:r>
                        <a:rPr lang="es-ES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hydrogenase</a:t>
                      </a:r>
                      <a:endParaRPr lang="es-E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02" marR="5802" marT="58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pic>
        <p:nvPicPr>
          <p:cNvPr id="4" name="Imagen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95" t="5573" r="4584"/>
          <a:stretch/>
        </p:blipFill>
        <p:spPr>
          <a:xfrm>
            <a:off x="419675" y="285749"/>
            <a:ext cx="5746302" cy="24669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33846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2</TotalTime>
  <Words>282</Words>
  <Application>Microsoft Office PowerPoint</Application>
  <PresentationFormat>Presentación en pantalla (4:3)</PresentationFormat>
  <Paragraphs>99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lba</dc:creator>
  <cp:lastModifiedBy>alba</cp:lastModifiedBy>
  <cp:revision>9</cp:revision>
  <dcterms:created xsi:type="dcterms:W3CDTF">2016-01-07T15:37:18Z</dcterms:created>
  <dcterms:modified xsi:type="dcterms:W3CDTF">2016-01-08T15:45:28Z</dcterms:modified>
</cp:coreProperties>
</file>